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91"/>
    <p:restoredTop sz="94673"/>
  </p:normalViewPr>
  <p:slideViewPr>
    <p:cSldViewPr snapToGrid="0" snapToObjects="1">
      <p:cViewPr varScale="1">
        <p:scale>
          <a:sx n="120" d="100"/>
          <a:sy n="120" d="100"/>
        </p:scale>
        <p:origin x="192" y="10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A993976-4BA4-F841-BF46-91B545E6AB7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44ACA4CC-17E3-4742-98AD-573149AB7D6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B9AA8CD-0FD2-9043-A575-6C4084D48D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58716-8186-D94F-A695-A8491AC960BF}" type="datetimeFigureOut">
              <a:rPr lang="fr-FR" smtClean="0"/>
              <a:t>24/0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D6BBBB2-2B11-DC43-B9C5-CB1CBCE2B4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68EC03B-9CC1-DC43-8073-304255F177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6238D-7A73-2642-AD37-28514880F01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721641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23B60BC-DF29-5540-835F-F165E56843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C3032E16-27CE-C84B-A4F9-91A2E560607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0AB88D4-62FD-484E-80F6-F2C71AE876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58716-8186-D94F-A695-A8491AC960BF}" type="datetimeFigureOut">
              <a:rPr lang="fr-FR" smtClean="0"/>
              <a:t>24/0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9783FE9-6E92-B444-86DF-F855EC88E3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565BD36-2FDD-5F4B-A0A6-C5805DAE6F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6238D-7A73-2642-AD37-28514880F01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998679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DE33D42C-B384-744D-AD8A-D7D352D02A6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9AB9934E-2ED0-AF4E-92AA-02AAB0C7C6A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B169256-38D8-F840-817B-2BEACFB02B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58716-8186-D94F-A695-A8491AC960BF}" type="datetimeFigureOut">
              <a:rPr lang="fr-FR" smtClean="0"/>
              <a:t>24/0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7D7C3F7-F371-0F4F-84FA-7674408A77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79A0BA7-B363-7544-B1EE-DBA0E67DA1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6238D-7A73-2642-AD37-28514880F01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796241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4112D5E-8EFA-7640-A59B-E68060F15A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936AF0A6-0770-794D-B778-AAB55604575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A2AC111-1D8F-CD47-86CF-DDADABBB44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58716-8186-D94F-A695-A8491AC960BF}" type="datetimeFigureOut">
              <a:rPr lang="fr-FR" smtClean="0"/>
              <a:t>24/0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066AE19-9E37-DC47-8A1D-C7134C8D1B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29EC92C-D249-3447-8002-D4584A38F8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6238D-7A73-2642-AD37-28514880F01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123868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5D7959D-D2F6-E646-B3A7-4A785C4B9C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7096D93-4CC4-0E4B-BBFB-B289274E13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CEA876C-8DC8-4146-9791-8610ADD326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58716-8186-D94F-A695-A8491AC960BF}" type="datetimeFigureOut">
              <a:rPr lang="fr-FR" smtClean="0"/>
              <a:t>24/0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8A59F81-594A-7744-B9AB-7C746B3327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4FB38FE-7ECC-4F48-973A-36D0E76382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6238D-7A73-2642-AD37-28514880F01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803944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8E3CDFD-5EEF-3F4F-A03C-FDAF32A37A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1F39936-2A82-9F45-9A8F-EAD342E45F2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764C0041-27E8-EB46-A092-ACF152B2BE6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1DC0FD3-5F8C-7B4F-9145-81F55A48BE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58716-8186-D94F-A695-A8491AC960BF}" type="datetimeFigureOut">
              <a:rPr lang="fr-FR" smtClean="0"/>
              <a:t>24/02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8C1C5A9-167E-104C-B3CF-1D999348B3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22582836-B3D0-8C46-8D43-C3ACE4089B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6238D-7A73-2642-AD37-28514880F01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222511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E176DE9-D90F-F645-A0C6-C0F10DDAE0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0DADAC75-BAA5-D746-A80B-E71C6C634E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BB3401F5-6F6C-7C41-8948-A37AB267D2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8FC8B3E6-7AB8-7847-A30F-772CB598D7A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DCC712B7-9DCC-984B-9938-C16F4A904ED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7DCF470B-3388-9642-BEBC-C9947906ED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58716-8186-D94F-A695-A8491AC960BF}" type="datetimeFigureOut">
              <a:rPr lang="fr-FR" smtClean="0"/>
              <a:t>24/02/2021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305FA43D-CDF8-234A-B056-87D554F410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167F87D1-D40F-754D-81F2-CF6C70A779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6238D-7A73-2642-AD37-28514880F01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341441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2956B0A-7BEA-DC49-B830-7DFFDB1124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B96A3390-B127-8149-BA11-F2F31DBE46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58716-8186-D94F-A695-A8491AC960BF}" type="datetimeFigureOut">
              <a:rPr lang="fr-FR" smtClean="0"/>
              <a:t>24/02/2021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B3153729-6F9E-224D-B290-BFBF171AB9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B7EFC77E-DEB8-674E-A1FF-2A0200F552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6238D-7A73-2642-AD37-28514880F01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801724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132F3EEF-F4CC-FB44-AC4D-0481E0398C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58716-8186-D94F-A695-A8491AC960BF}" type="datetimeFigureOut">
              <a:rPr lang="fr-FR" smtClean="0"/>
              <a:t>24/02/2021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07EAC27E-4537-E948-B336-B358FABB0F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063A692D-35A4-6243-A40D-681BBEFCB5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6238D-7A73-2642-AD37-28514880F01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185920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A6BFA67-F27D-3C44-A5CF-95A58C6602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238CD5A9-B631-6749-960C-A0BE9563F57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C98EE88E-8D40-4B44-9760-9E5DB6CBA58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1837090-DAD1-2246-B7F1-504CC382FB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58716-8186-D94F-A695-A8491AC960BF}" type="datetimeFigureOut">
              <a:rPr lang="fr-FR" smtClean="0"/>
              <a:t>24/02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5037A78B-92B9-D64B-9AAE-0F5106A27A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2756BD99-DFE7-2747-9721-8CF508ADBD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6238D-7A73-2642-AD37-28514880F01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616742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796CE6B-C10C-5643-9218-B9F9679DE3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796FD290-A554-F54A-9DEE-F42A042BE69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9EC4F4C1-3945-AE41-A0B6-897B393FFD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CC5C3183-FA0C-C64E-B03C-A50F66F3F3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58716-8186-D94F-A695-A8491AC960BF}" type="datetimeFigureOut">
              <a:rPr lang="fr-FR" smtClean="0"/>
              <a:t>24/02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412444B4-33EB-FB45-956C-00D08B13B6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F6BE320-107C-EC4B-9987-C5FF95E5AE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6238D-7A73-2642-AD37-28514880F01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62242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F6543A4E-CA1F-5945-BA97-E4398994F8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67E64DF8-357A-1E46-9B2D-7BB24FD6C2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2755347-4AD0-734F-8963-2257D56786A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58716-8186-D94F-A695-A8491AC960BF}" type="datetimeFigureOut">
              <a:rPr lang="fr-FR" smtClean="0"/>
              <a:t>24/0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DCB5D5F-97A8-6749-8D7F-CC64D6A58FC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B06F045-CF8C-B147-9EB8-F19EF5C2912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C6238D-7A73-2642-AD37-28514880F01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30861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e 3">
            <a:extLst>
              <a:ext uri="{FF2B5EF4-FFF2-40B4-BE49-F238E27FC236}">
                <a16:creationId xmlns:a16="http://schemas.microsoft.com/office/drawing/2014/main" id="{D34AFF81-0126-B544-B695-5EF34B58B754}"/>
              </a:ext>
            </a:extLst>
          </p:cNvPr>
          <p:cNvGrpSpPr/>
          <p:nvPr/>
        </p:nvGrpSpPr>
        <p:grpSpPr>
          <a:xfrm>
            <a:off x="4060288" y="1308786"/>
            <a:ext cx="8025382" cy="5461910"/>
            <a:chOff x="4166618" y="1308786"/>
            <a:chExt cx="8025382" cy="5461910"/>
          </a:xfrm>
        </p:grpSpPr>
        <p:grpSp>
          <p:nvGrpSpPr>
            <p:cNvPr id="5" name="Groupe 4">
              <a:extLst>
                <a:ext uri="{FF2B5EF4-FFF2-40B4-BE49-F238E27FC236}">
                  <a16:creationId xmlns:a16="http://schemas.microsoft.com/office/drawing/2014/main" id="{01DED71F-0698-9047-9F99-850AEF440840}"/>
                </a:ext>
              </a:extLst>
            </p:cNvPr>
            <p:cNvGrpSpPr/>
            <p:nvPr/>
          </p:nvGrpSpPr>
          <p:grpSpPr>
            <a:xfrm>
              <a:off x="4166618" y="1308786"/>
              <a:ext cx="8025382" cy="5309151"/>
              <a:chOff x="3814062" y="778295"/>
              <a:chExt cx="8025382" cy="5309151"/>
            </a:xfrm>
          </p:grpSpPr>
          <p:pic>
            <p:nvPicPr>
              <p:cNvPr id="7" name="Image 6">
                <a:extLst>
                  <a:ext uri="{FF2B5EF4-FFF2-40B4-BE49-F238E27FC236}">
                    <a16:creationId xmlns:a16="http://schemas.microsoft.com/office/drawing/2014/main" id="{732063F5-6F83-4241-A810-60CC255D5B2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3814062" y="778295"/>
                <a:ext cx="8025382" cy="5074873"/>
              </a:xfrm>
              <a:prstGeom prst="rect">
                <a:avLst/>
              </a:prstGeom>
            </p:spPr>
          </p:pic>
          <p:sp>
            <p:nvSpPr>
              <p:cNvPr id="8" name="Ellipse 7">
                <a:extLst>
                  <a:ext uri="{FF2B5EF4-FFF2-40B4-BE49-F238E27FC236}">
                    <a16:creationId xmlns:a16="http://schemas.microsoft.com/office/drawing/2014/main" id="{9165952D-2B73-4F46-A298-AAE62D2774F9}"/>
                  </a:ext>
                </a:extLst>
              </p:cNvPr>
              <p:cNvSpPr/>
              <p:nvPr/>
            </p:nvSpPr>
            <p:spPr>
              <a:xfrm rot="19159269">
                <a:off x="4615763" y="1551367"/>
                <a:ext cx="1159156" cy="4348879"/>
              </a:xfrm>
              <a:prstGeom prst="ellipse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9" name="Ellipse 8">
                <a:extLst>
                  <a:ext uri="{FF2B5EF4-FFF2-40B4-BE49-F238E27FC236}">
                    <a16:creationId xmlns:a16="http://schemas.microsoft.com/office/drawing/2014/main" id="{82714A7B-E833-2D4C-B517-322C9AD60C62}"/>
                  </a:ext>
                </a:extLst>
              </p:cNvPr>
              <p:cNvSpPr/>
              <p:nvPr/>
            </p:nvSpPr>
            <p:spPr>
              <a:xfrm rot="2823065">
                <a:off x="5235231" y="4420122"/>
                <a:ext cx="1539743" cy="625476"/>
              </a:xfrm>
              <a:prstGeom prst="ellipse">
                <a:avLst/>
              </a:prstGeom>
              <a:noFill/>
              <a:ln w="19050">
                <a:solidFill>
                  <a:schemeClr val="accent1">
                    <a:lumMod val="75000"/>
                  </a:schemeClr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0" name="Ellipse 9">
                <a:extLst>
                  <a:ext uri="{FF2B5EF4-FFF2-40B4-BE49-F238E27FC236}">
                    <a16:creationId xmlns:a16="http://schemas.microsoft.com/office/drawing/2014/main" id="{1088B0A4-4FDE-A04E-869F-C22987EE2CA0}"/>
                  </a:ext>
                </a:extLst>
              </p:cNvPr>
              <p:cNvSpPr/>
              <p:nvPr/>
            </p:nvSpPr>
            <p:spPr>
              <a:xfrm rot="18939254">
                <a:off x="7005339" y="2696709"/>
                <a:ext cx="1330869" cy="925215"/>
              </a:xfrm>
              <a:prstGeom prst="ellipse">
                <a:avLst/>
              </a:prstGeom>
              <a:noFill/>
              <a:ln w="19050">
                <a:solidFill>
                  <a:schemeClr val="accent1">
                    <a:lumMod val="75000"/>
                  </a:schemeClr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1" name="Ellipse 10">
                <a:extLst>
                  <a:ext uri="{FF2B5EF4-FFF2-40B4-BE49-F238E27FC236}">
                    <a16:creationId xmlns:a16="http://schemas.microsoft.com/office/drawing/2014/main" id="{AFBAC804-39AE-8142-B59A-2A18693D1AF4}"/>
                  </a:ext>
                </a:extLst>
              </p:cNvPr>
              <p:cNvSpPr/>
              <p:nvPr/>
            </p:nvSpPr>
            <p:spPr>
              <a:xfrm rot="3054981">
                <a:off x="3601089" y="2426460"/>
                <a:ext cx="1442633" cy="557827"/>
              </a:xfrm>
              <a:prstGeom prst="ellipse">
                <a:avLst/>
              </a:prstGeom>
              <a:noFill/>
              <a:ln w="19050">
                <a:solidFill>
                  <a:schemeClr val="accent1">
                    <a:lumMod val="75000"/>
                  </a:schemeClr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2" name="Ellipse 11">
                <a:extLst>
                  <a:ext uri="{FF2B5EF4-FFF2-40B4-BE49-F238E27FC236}">
                    <a16:creationId xmlns:a16="http://schemas.microsoft.com/office/drawing/2014/main" id="{C8350881-A2B9-D041-A67D-26DD3B83D62D}"/>
                  </a:ext>
                </a:extLst>
              </p:cNvPr>
              <p:cNvSpPr/>
              <p:nvPr/>
            </p:nvSpPr>
            <p:spPr>
              <a:xfrm rot="2977049">
                <a:off x="6109651" y="2236647"/>
                <a:ext cx="1010807" cy="693505"/>
              </a:xfrm>
              <a:prstGeom prst="ellipse">
                <a:avLst/>
              </a:prstGeom>
              <a:noFill/>
              <a:ln w="19050">
                <a:solidFill>
                  <a:schemeClr val="accent1">
                    <a:lumMod val="75000"/>
                  </a:schemeClr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3" name="ZoneTexte 12">
                <a:extLst>
                  <a:ext uri="{FF2B5EF4-FFF2-40B4-BE49-F238E27FC236}">
                    <a16:creationId xmlns:a16="http://schemas.microsoft.com/office/drawing/2014/main" id="{A4C840F5-98CC-B847-833B-C8AEE5C192AE}"/>
                  </a:ext>
                </a:extLst>
              </p:cNvPr>
              <p:cNvSpPr txBox="1"/>
              <p:nvPr/>
            </p:nvSpPr>
            <p:spPr>
              <a:xfrm>
                <a:off x="7589331" y="2247851"/>
                <a:ext cx="54854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dirty="0"/>
                  <a:t>CC3</a:t>
                </a:r>
              </a:p>
            </p:txBody>
          </p:sp>
          <p:sp>
            <p:nvSpPr>
              <p:cNvPr id="14" name="ZoneTexte 13">
                <a:extLst>
                  <a:ext uri="{FF2B5EF4-FFF2-40B4-BE49-F238E27FC236}">
                    <a16:creationId xmlns:a16="http://schemas.microsoft.com/office/drawing/2014/main" id="{AE3FF242-8009-534D-9A87-468FBCB07D9F}"/>
                  </a:ext>
                </a:extLst>
              </p:cNvPr>
              <p:cNvSpPr txBox="1"/>
              <p:nvPr/>
            </p:nvSpPr>
            <p:spPr>
              <a:xfrm>
                <a:off x="6591437" y="1869942"/>
                <a:ext cx="54854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dirty="0"/>
                  <a:t>CC8</a:t>
                </a:r>
              </a:p>
            </p:txBody>
          </p:sp>
          <p:sp>
            <p:nvSpPr>
              <p:cNvPr id="15" name="ZoneTexte 14">
                <a:extLst>
                  <a:ext uri="{FF2B5EF4-FFF2-40B4-BE49-F238E27FC236}">
                    <a16:creationId xmlns:a16="http://schemas.microsoft.com/office/drawing/2014/main" id="{5ADF7246-2E8A-BB49-8A48-1BEDBDFE2D5B}"/>
                  </a:ext>
                </a:extLst>
              </p:cNvPr>
              <p:cNvSpPr txBox="1"/>
              <p:nvPr/>
            </p:nvSpPr>
            <p:spPr>
              <a:xfrm>
                <a:off x="4821778" y="2987108"/>
                <a:ext cx="54854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dirty="0"/>
                  <a:t>CC7</a:t>
                </a:r>
              </a:p>
            </p:txBody>
          </p:sp>
          <p:sp>
            <p:nvSpPr>
              <p:cNvPr id="16" name="ZoneTexte 15">
                <a:extLst>
                  <a:ext uri="{FF2B5EF4-FFF2-40B4-BE49-F238E27FC236}">
                    <a16:creationId xmlns:a16="http://schemas.microsoft.com/office/drawing/2014/main" id="{155A0FA3-3B0B-4342-8EF8-205774A65BD6}"/>
                  </a:ext>
                </a:extLst>
              </p:cNvPr>
              <p:cNvSpPr txBox="1"/>
              <p:nvPr/>
            </p:nvSpPr>
            <p:spPr>
              <a:xfrm>
                <a:off x="4921184" y="4062602"/>
                <a:ext cx="54854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dirty="0"/>
                  <a:t>CC6</a:t>
                </a:r>
              </a:p>
            </p:txBody>
          </p:sp>
          <p:sp>
            <p:nvSpPr>
              <p:cNvPr id="17" name="ZoneTexte 16">
                <a:extLst>
                  <a:ext uri="{FF2B5EF4-FFF2-40B4-BE49-F238E27FC236}">
                    <a16:creationId xmlns:a16="http://schemas.microsoft.com/office/drawing/2014/main" id="{1FDE5A42-7AAF-2D40-B1F0-D9543ED8F797}"/>
                  </a:ext>
                </a:extLst>
              </p:cNvPr>
              <p:cNvSpPr txBox="1"/>
              <p:nvPr/>
            </p:nvSpPr>
            <p:spPr>
              <a:xfrm>
                <a:off x="4116480" y="4077646"/>
                <a:ext cx="697627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2400" b="1" dirty="0">
                    <a:solidFill>
                      <a:srgbClr val="FF0000"/>
                    </a:solidFill>
                  </a:rPr>
                  <a:t>GC2</a:t>
                </a:r>
              </a:p>
            </p:txBody>
          </p:sp>
          <p:sp>
            <p:nvSpPr>
              <p:cNvPr id="18" name="Ellipse 17">
                <a:extLst>
                  <a:ext uri="{FF2B5EF4-FFF2-40B4-BE49-F238E27FC236}">
                    <a16:creationId xmlns:a16="http://schemas.microsoft.com/office/drawing/2014/main" id="{1A46A6E3-839D-D24E-B592-0EC06FAD8B2A}"/>
                  </a:ext>
                </a:extLst>
              </p:cNvPr>
              <p:cNvSpPr/>
              <p:nvPr/>
            </p:nvSpPr>
            <p:spPr>
              <a:xfrm rot="316771">
                <a:off x="9863634" y="3788229"/>
                <a:ext cx="1572304" cy="717626"/>
              </a:xfrm>
              <a:prstGeom prst="ellipse">
                <a:avLst/>
              </a:prstGeom>
              <a:noFill/>
              <a:ln w="19050">
                <a:solidFill>
                  <a:schemeClr val="accent1">
                    <a:lumMod val="75000"/>
                  </a:schemeClr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9" name="Ellipse 18">
                <a:extLst>
                  <a:ext uri="{FF2B5EF4-FFF2-40B4-BE49-F238E27FC236}">
                    <a16:creationId xmlns:a16="http://schemas.microsoft.com/office/drawing/2014/main" id="{62F28081-54A3-1F43-9F7E-F30D0404D358}"/>
                  </a:ext>
                </a:extLst>
              </p:cNvPr>
              <p:cNvSpPr/>
              <p:nvPr/>
            </p:nvSpPr>
            <p:spPr>
              <a:xfrm rot="159524">
                <a:off x="7870000" y="4653256"/>
                <a:ext cx="1816622" cy="1434190"/>
              </a:xfrm>
              <a:prstGeom prst="ellipse">
                <a:avLst/>
              </a:prstGeom>
              <a:noFill/>
              <a:ln w="19050">
                <a:solidFill>
                  <a:schemeClr val="accent1">
                    <a:lumMod val="75000"/>
                  </a:schemeClr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0" name="Ellipse 19">
                <a:extLst>
                  <a:ext uri="{FF2B5EF4-FFF2-40B4-BE49-F238E27FC236}">
                    <a16:creationId xmlns:a16="http://schemas.microsoft.com/office/drawing/2014/main" id="{3DF55412-A207-9A4A-A4C1-9D92EF71D988}"/>
                  </a:ext>
                </a:extLst>
              </p:cNvPr>
              <p:cNvSpPr/>
              <p:nvPr/>
            </p:nvSpPr>
            <p:spPr>
              <a:xfrm rot="2716680">
                <a:off x="9138854" y="2135363"/>
                <a:ext cx="1632731" cy="1108929"/>
              </a:xfrm>
              <a:prstGeom prst="ellipse">
                <a:avLst/>
              </a:prstGeom>
              <a:noFill/>
              <a:ln w="19050">
                <a:solidFill>
                  <a:schemeClr val="accent1">
                    <a:lumMod val="75000"/>
                  </a:schemeClr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1" name="Forme libre 20">
                <a:extLst>
                  <a:ext uri="{FF2B5EF4-FFF2-40B4-BE49-F238E27FC236}">
                    <a16:creationId xmlns:a16="http://schemas.microsoft.com/office/drawing/2014/main" id="{D9112726-E1FF-C442-A234-DA4AD97358F9}"/>
                  </a:ext>
                </a:extLst>
              </p:cNvPr>
              <p:cNvSpPr/>
              <p:nvPr/>
            </p:nvSpPr>
            <p:spPr>
              <a:xfrm rot="20330607">
                <a:off x="8629507" y="3631641"/>
                <a:ext cx="1195240" cy="1180074"/>
              </a:xfrm>
              <a:custGeom>
                <a:avLst/>
                <a:gdLst>
                  <a:gd name="connsiteX0" fmla="*/ 246388 w 1190285"/>
                  <a:gd name="connsiteY0" fmla="*/ 0 h 1238864"/>
                  <a:gd name="connsiteX1" fmla="*/ 108736 w 1190285"/>
                  <a:gd name="connsiteY1" fmla="*/ 9832 h 1238864"/>
                  <a:gd name="connsiteX2" fmla="*/ 39910 w 1190285"/>
                  <a:gd name="connsiteY2" fmla="*/ 29496 h 1238864"/>
                  <a:gd name="connsiteX3" fmla="*/ 30078 w 1190285"/>
                  <a:gd name="connsiteY3" fmla="*/ 58993 h 1238864"/>
                  <a:gd name="connsiteX4" fmla="*/ 581 w 1190285"/>
                  <a:gd name="connsiteY4" fmla="*/ 78658 h 1238864"/>
                  <a:gd name="connsiteX5" fmla="*/ 20246 w 1190285"/>
                  <a:gd name="connsiteY5" fmla="*/ 265471 h 1238864"/>
                  <a:gd name="connsiteX6" fmla="*/ 30078 w 1190285"/>
                  <a:gd name="connsiteY6" fmla="*/ 294967 h 1238864"/>
                  <a:gd name="connsiteX7" fmla="*/ 69407 w 1190285"/>
                  <a:gd name="connsiteY7" fmla="*/ 353961 h 1238864"/>
                  <a:gd name="connsiteX8" fmla="*/ 128401 w 1190285"/>
                  <a:gd name="connsiteY8" fmla="*/ 373625 h 1238864"/>
                  <a:gd name="connsiteX9" fmla="*/ 187394 w 1190285"/>
                  <a:gd name="connsiteY9" fmla="*/ 422787 h 1238864"/>
                  <a:gd name="connsiteX10" fmla="*/ 226723 w 1190285"/>
                  <a:gd name="connsiteY10" fmla="*/ 481780 h 1238864"/>
                  <a:gd name="connsiteX11" fmla="*/ 246388 w 1190285"/>
                  <a:gd name="connsiteY11" fmla="*/ 511277 h 1238864"/>
                  <a:gd name="connsiteX12" fmla="*/ 315214 w 1190285"/>
                  <a:gd name="connsiteY12" fmla="*/ 599767 h 1238864"/>
                  <a:gd name="connsiteX13" fmla="*/ 354543 w 1190285"/>
                  <a:gd name="connsiteY13" fmla="*/ 658761 h 1238864"/>
                  <a:gd name="connsiteX14" fmla="*/ 384039 w 1190285"/>
                  <a:gd name="connsiteY14" fmla="*/ 688258 h 1238864"/>
                  <a:gd name="connsiteX15" fmla="*/ 423368 w 1190285"/>
                  <a:gd name="connsiteY15" fmla="*/ 747251 h 1238864"/>
                  <a:gd name="connsiteX16" fmla="*/ 443033 w 1190285"/>
                  <a:gd name="connsiteY16" fmla="*/ 776748 h 1238864"/>
                  <a:gd name="connsiteX17" fmla="*/ 472530 w 1190285"/>
                  <a:gd name="connsiteY17" fmla="*/ 796413 h 1238864"/>
                  <a:gd name="connsiteX18" fmla="*/ 541356 w 1190285"/>
                  <a:gd name="connsiteY18" fmla="*/ 875071 h 1238864"/>
                  <a:gd name="connsiteX19" fmla="*/ 580685 w 1190285"/>
                  <a:gd name="connsiteY19" fmla="*/ 934064 h 1238864"/>
                  <a:gd name="connsiteX20" fmla="*/ 639678 w 1190285"/>
                  <a:gd name="connsiteY20" fmla="*/ 993058 h 1238864"/>
                  <a:gd name="connsiteX21" fmla="*/ 688839 w 1190285"/>
                  <a:gd name="connsiteY21" fmla="*/ 1042219 h 1238864"/>
                  <a:gd name="connsiteX22" fmla="*/ 738001 w 1190285"/>
                  <a:gd name="connsiteY22" fmla="*/ 1091380 h 1238864"/>
                  <a:gd name="connsiteX23" fmla="*/ 787162 w 1190285"/>
                  <a:gd name="connsiteY23" fmla="*/ 1150374 h 1238864"/>
                  <a:gd name="connsiteX24" fmla="*/ 846156 w 1190285"/>
                  <a:gd name="connsiteY24" fmla="*/ 1189703 h 1238864"/>
                  <a:gd name="connsiteX25" fmla="*/ 875652 w 1190285"/>
                  <a:gd name="connsiteY25" fmla="*/ 1209367 h 1238864"/>
                  <a:gd name="connsiteX26" fmla="*/ 905149 w 1190285"/>
                  <a:gd name="connsiteY26" fmla="*/ 1219200 h 1238864"/>
                  <a:gd name="connsiteX27" fmla="*/ 1062465 w 1190285"/>
                  <a:gd name="connsiteY27" fmla="*/ 1238864 h 1238864"/>
                  <a:gd name="connsiteX28" fmla="*/ 1121459 w 1190285"/>
                  <a:gd name="connsiteY28" fmla="*/ 1219200 h 1238864"/>
                  <a:gd name="connsiteX29" fmla="*/ 1150956 w 1190285"/>
                  <a:gd name="connsiteY29" fmla="*/ 1209367 h 1238864"/>
                  <a:gd name="connsiteX30" fmla="*/ 1170620 w 1190285"/>
                  <a:gd name="connsiteY30" fmla="*/ 1179871 h 1238864"/>
                  <a:gd name="connsiteX31" fmla="*/ 1190285 w 1190285"/>
                  <a:gd name="connsiteY31" fmla="*/ 1081548 h 1238864"/>
                  <a:gd name="connsiteX32" fmla="*/ 1160788 w 1190285"/>
                  <a:gd name="connsiteY32" fmla="*/ 924232 h 1238864"/>
                  <a:gd name="connsiteX33" fmla="*/ 1150956 w 1190285"/>
                  <a:gd name="connsiteY33" fmla="*/ 894735 h 1238864"/>
                  <a:gd name="connsiteX34" fmla="*/ 1111627 w 1190285"/>
                  <a:gd name="connsiteY34" fmla="*/ 835742 h 1238864"/>
                  <a:gd name="connsiteX35" fmla="*/ 1101794 w 1190285"/>
                  <a:gd name="connsiteY35" fmla="*/ 806245 h 1238864"/>
                  <a:gd name="connsiteX36" fmla="*/ 1082130 w 1190285"/>
                  <a:gd name="connsiteY36" fmla="*/ 776748 h 1238864"/>
                  <a:gd name="connsiteX37" fmla="*/ 1062465 w 1190285"/>
                  <a:gd name="connsiteY37" fmla="*/ 717754 h 1238864"/>
                  <a:gd name="connsiteX38" fmla="*/ 1023136 w 1190285"/>
                  <a:gd name="connsiteY38" fmla="*/ 599767 h 1238864"/>
                  <a:gd name="connsiteX39" fmla="*/ 1013304 w 1190285"/>
                  <a:gd name="connsiteY39" fmla="*/ 570271 h 1238864"/>
                  <a:gd name="connsiteX40" fmla="*/ 1003472 w 1190285"/>
                  <a:gd name="connsiteY40" fmla="*/ 540774 h 1238864"/>
                  <a:gd name="connsiteX41" fmla="*/ 983807 w 1190285"/>
                  <a:gd name="connsiteY41" fmla="*/ 511277 h 1238864"/>
                  <a:gd name="connsiteX42" fmla="*/ 964143 w 1190285"/>
                  <a:gd name="connsiteY42" fmla="*/ 452283 h 1238864"/>
                  <a:gd name="connsiteX43" fmla="*/ 954310 w 1190285"/>
                  <a:gd name="connsiteY43" fmla="*/ 422787 h 1238864"/>
                  <a:gd name="connsiteX44" fmla="*/ 924814 w 1190285"/>
                  <a:gd name="connsiteY44" fmla="*/ 393290 h 1238864"/>
                  <a:gd name="connsiteX45" fmla="*/ 885485 w 1190285"/>
                  <a:gd name="connsiteY45" fmla="*/ 334296 h 1238864"/>
                  <a:gd name="connsiteX46" fmla="*/ 826491 w 1190285"/>
                  <a:gd name="connsiteY46" fmla="*/ 285135 h 1238864"/>
                  <a:gd name="connsiteX47" fmla="*/ 738001 w 1190285"/>
                  <a:gd name="connsiteY47" fmla="*/ 235974 h 1238864"/>
                  <a:gd name="connsiteX48" fmla="*/ 649510 w 1190285"/>
                  <a:gd name="connsiteY48" fmla="*/ 186813 h 1238864"/>
                  <a:gd name="connsiteX49" fmla="*/ 590517 w 1190285"/>
                  <a:gd name="connsiteY49" fmla="*/ 157316 h 1238864"/>
                  <a:gd name="connsiteX50" fmla="*/ 531523 w 1190285"/>
                  <a:gd name="connsiteY50" fmla="*/ 127819 h 1238864"/>
                  <a:gd name="connsiteX51" fmla="*/ 472530 w 1190285"/>
                  <a:gd name="connsiteY51" fmla="*/ 98322 h 1238864"/>
                  <a:gd name="connsiteX52" fmla="*/ 443033 w 1190285"/>
                  <a:gd name="connsiteY52" fmla="*/ 78658 h 1238864"/>
                  <a:gd name="connsiteX53" fmla="*/ 384039 w 1190285"/>
                  <a:gd name="connsiteY53" fmla="*/ 58993 h 1238864"/>
                  <a:gd name="connsiteX54" fmla="*/ 354543 w 1190285"/>
                  <a:gd name="connsiteY54" fmla="*/ 49161 h 1238864"/>
                  <a:gd name="connsiteX55" fmla="*/ 325046 w 1190285"/>
                  <a:gd name="connsiteY55" fmla="*/ 39329 h 1238864"/>
                  <a:gd name="connsiteX56" fmla="*/ 266052 w 1190285"/>
                  <a:gd name="connsiteY56" fmla="*/ 9832 h 1238864"/>
                  <a:gd name="connsiteX57" fmla="*/ 246388 w 1190285"/>
                  <a:gd name="connsiteY57" fmla="*/ 0 h 123886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</a:cxnLst>
                <a:rect l="l" t="t" r="r" b="b"/>
                <a:pathLst>
                  <a:path w="1190285" h="1238864">
                    <a:moveTo>
                      <a:pt x="246388" y="0"/>
                    </a:moveTo>
                    <a:cubicBezTo>
                      <a:pt x="220169" y="0"/>
                      <a:pt x="154456" y="4752"/>
                      <a:pt x="108736" y="9832"/>
                    </a:cubicBezTo>
                    <a:cubicBezTo>
                      <a:pt x="90218" y="11890"/>
                      <a:pt x="58554" y="23282"/>
                      <a:pt x="39910" y="29496"/>
                    </a:cubicBezTo>
                    <a:cubicBezTo>
                      <a:pt x="36633" y="39328"/>
                      <a:pt x="36552" y="50900"/>
                      <a:pt x="30078" y="58993"/>
                    </a:cubicBezTo>
                    <a:cubicBezTo>
                      <a:pt x="22696" y="68221"/>
                      <a:pt x="2143" y="66945"/>
                      <a:pt x="581" y="78658"/>
                    </a:cubicBezTo>
                    <a:cubicBezTo>
                      <a:pt x="-2949" y="105135"/>
                      <a:pt x="10337" y="220879"/>
                      <a:pt x="20246" y="265471"/>
                    </a:cubicBezTo>
                    <a:cubicBezTo>
                      <a:pt x="22494" y="275588"/>
                      <a:pt x="25045" y="285907"/>
                      <a:pt x="30078" y="294967"/>
                    </a:cubicBezTo>
                    <a:cubicBezTo>
                      <a:pt x="41556" y="315627"/>
                      <a:pt x="46986" y="346488"/>
                      <a:pt x="69407" y="353961"/>
                    </a:cubicBezTo>
                    <a:lnTo>
                      <a:pt x="128401" y="373625"/>
                    </a:lnTo>
                    <a:cubicBezTo>
                      <a:pt x="154619" y="391105"/>
                      <a:pt x="167012" y="396582"/>
                      <a:pt x="187394" y="422787"/>
                    </a:cubicBezTo>
                    <a:cubicBezTo>
                      <a:pt x="201904" y="441442"/>
                      <a:pt x="213613" y="462116"/>
                      <a:pt x="226723" y="481780"/>
                    </a:cubicBezTo>
                    <a:cubicBezTo>
                      <a:pt x="233278" y="491612"/>
                      <a:pt x="238032" y="502921"/>
                      <a:pt x="246388" y="511277"/>
                    </a:cubicBezTo>
                    <a:cubicBezTo>
                      <a:pt x="292595" y="557484"/>
                      <a:pt x="268174" y="529206"/>
                      <a:pt x="315214" y="599767"/>
                    </a:cubicBezTo>
                    <a:cubicBezTo>
                      <a:pt x="315217" y="599772"/>
                      <a:pt x="354539" y="658757"/>
                      <a:pt x="354543" y="658761"/>
                    </a:cubicBezTo>
                    <a:cubicBezTo>
                      <a:pt x="364375" y="668593"/>
                      <a:pt x="375502" y="677282"/>
                      <a:pt x="384039" y="688258"/>
                    </a:cubicBezTo>
                    <a:cubicBezTo>
                      <a:pt x="398549" y="706913"/>
                      <a:pt x="410258" y="727587"/>
                      <a:pt x="423368" y="747251"/>
                    </a:cubicBezTo>
                    <a:cubicBezTo>
                      <a:pt x="429923" y="757083"/>
                      <a:pt x="433201" y="770193"/>
                      <a:pt x="443033" y="776748"/>
                    </a:cubicBezTo>
                    <a:lnTo>
                      <a:pt x="472530" y="796413"/>
                    </a:lnTo>
                    <a:cubicBezTo>
                      <a:pt x="518414" y="865238"/>
                      <a:pt x="492195" y="842296"/>
                      <a:pt x="541356" y="875071"/>
                    </a:cubicBezTo>
                    <a:cubicBezTo>
                      <a:pt x="554466" y="894735"/>
                      <a:pt x="563974" y="917352"/>
                      <a:pt x="580685" y="934064"/>
                    </a:cubicBezTo>
                    <a:cubicBezTo>
                      <a:pt x="600349" y="953729"/>
                      <a:pt x="624251" y="969919"/>
                      <a:pt x="639678" y="993058"/>
                    </a:cubicBezTo>
                    <a:cubicBezTo>
                      <a:pt x="665898" y="1032386"/>
                      <a:pt x="649511" y="1015999"/>
                      <a:pt x="688839" y="1042219"/>
                    </a:cubicBezTo>
                    <a:cubicBezTo>
                      <a:pt x="741282" y="1120882"/>
                      <a:pt x="672449" y="1025828"/>
                      <a:pt x="738001" y="1091380"/>
                    </a:cubicBezTo>
                    <a:cubicBezTo>
                      <a:pt x="794813" y="1148192"/>
                      <a:pt x="714673" y="1093994"/>
                      <a:pt x="787162" y="1150374"/>
                    </a:cubicBezTo>
                    <a:cubicBezTo>
                      <a:pt x="805818" y="1164884"/>
                      <a:pt x="826491" y="1176593"/>
                      <a:pt x="846156" y="1189703"/>
                    </a:cubicBezTo>
                    <a:cubicBezTo>
                      <a:pt x="855988" y="1196258"/>
                      <a:pt x="864442" y="1205630"/>
                      <a:pt x="875652" y="1209367"/>
                    </a:cubicBezTo>
                    <a:cubicBezTo>
                      <a:pt x="885484" y="1212645"/>
                      <a:pt x="895032" y="1216952"/>
                      <a:pt x="905149" y="1219200"/>
                    </a:cubicBezTo>
                    <a:cubicBezTo>
                      <a:pt x="955044" y="1230288"/>
                      <a:pt x="1013017" y="1233919"/>
                      <a:pt x="1062465" y="1238864"/>
                    </a:cubicBezTo>
                    <a:lnTo>
                      <a:pt x="1121459" y="1219200"/>
                    </a:lnTo>
                    <a:lnTo>
                      <a:pt x="1150956" y="1209367"/>
                    </a:lnTo>
                    <a:cubicBezTo>
                      <a:pt x="1157511" y="1199535"/>
                      <a:pt x="1165336" y="1190440"/>
                      <a:pt x="1170620" y="1179871"/>
                    </a:cubicBezTo>
                    <a:cubicBezTo>
                      <a:pt x="1184348" y="1152415"/>
                      <a:pt x="1186662" y="1106908"/>
                      <a:pt x="1190285" y="1081548"/>
                    </a:cubicBezTo>
                    <a:cubicBezTo>
                      <a:pt x="1178389" y="962599"/>
                      <a:pt x="1190868" y="1014473"/>
                      <a:pt x="1160788" y="924232"/>
                    </a:cubicBezTo>
                    <a:cubicBezTo>
                      <a:pt x="1157511" y="914400"/>
                      <a:pt x="1156705" y="903358"/>
                      <a:pt x="1150956" y="894735"/>
                    </a:cubicBezTo>
                    <a:cubicBezTo>
                      <a:pt x="1137846" y="875071"/>
                      <a:pt x="1119101" y="858163"/>
                      <a:pt x="1111627" y="835742"/>
                    </a:cubicBezTo>
                    <a:cubicBezTo>
                      <a:pt x="1108349" y="825910"/>
                      <a:pt x="1106429" y="815515"/>
                      <a:pt x="1101794" y="806245"/>
                    </a:cubicBezTo>
                    <a:cubicBezTo>
                      <a:pt x="1096509" y="795676"/>
                      <a:pt x="1086929" y="787546"/>
                      <a:pt x="1082130" y="776748"/>
                    </a:cubicBezTo>
                    <a:cubicBezTo>
                      <a:pt x="1073711" y="757806"/>
                      <a:pt x="1069020" y="737419"/>
                      <a:pt x="1062465" y="717754"/>
                    </a:cubicBezTo>
                    <a:lnTo>
                      <a:pt x="1023136" y="599767"/>
                    </a:lnTo>
                    <a:lnTo>
                      <a:pt x="1013304" y="570271"/>
                    </a:lnTo>
                    <a:cubicBezTo>
                      <a:pt x="1010027" y="560439"/>
                      <a:pt x="1009221" y="549397"/>
                      <a:pt x="1003472" y="540774"/>
                    </a:cubicBezTo>
                    <a:lnTo>
                      <a:pt x="983807" y="511277"/>
                    </a:lnTo>
                    <a:lnTo>
                      <a:pt x="964143" y="452283"/>
                    </a:lnTo>
                    <a:cubicBezTo>
                      <a:pt x="960866" y="442451"/>
                      <a:pt x="961638" y="430116"/>
                      <a:pt x="954310" y="422787"/>
                    </a:cubicBezTo>
                    <a:cubicBezTo>
                      <a:pt x="944478" y="412955"/>
                      <a:pt x="933351" y="404266"/>
                      <a:pt x="924814" y="393290"/>
                    </a:cubicBezTo>
                    <a:cubicBezTo>
                      <a:pt x="910304" y="374634"/>
                      <a:pt x="905150" y="347405"/>
                      <a:pt x="885485" y="334296"/>
                    </a:cubicBezTo>
                    <a:cubicBezTo>
                      <a:pt x="780091" y="264036"/>
                      <a:pt x="940038" y="373449"/>
                      <a:pt x="826491" y="285135"/>
                    </a:cubicBezTo>
                    <a:cubicBezTo>
                      <a:pt x="775778" y="245692"/>
                      <a:pt x="782505" y="250809"/>
                      <a:pt x="738001" y="235974"/>
                    </a:cubicBezTo>
                    <a:cubicBezTo>
                      <a:pt x="670383" y="190896"/>
                      <a:pt x="701428" y="204118"/>
                      <a:pt x="649510" y="186813"/>
                    </a:cubicBezTo>
                    <a:cubicBezTo>
                      <a:pt x="564984" y="130459"/>
                      <a:pt x="671926" y="198021"/>
                      <a:pt x="590517" y="157316"/>
                    </a:cubicBezTo>
                    <a:cubicBezTo>
                      <a:pt x="514276" y="119196"/>
                      <a:pt x="605664" y="152532"/>
                      <a:pt x="531523" y="127819"/>
                    </a:cubicBezTo>
                    <a:cubicBezTo>
                      <a:pt x="447006" y="71472"/>
                      <a:pt x="553931" y="139021"/>
                      <a:pt x="472530" y="98322"/>
                    </a:cubicBezTo>
                    <a:cubicBezTo>
                      <a:pt x="461961" y="93037"/>
                      <a:pt x="453831" y="83457"/>
                      <a:pt x="443033" y="78658"/>
                    </a:cubicBezTo>
                    <a:cubicBezTo>
                      <a:pt x="424091" y="70239"/>
                      <a:pt x="403704" y="65548"/>
                      <a:pt x="384039" y="58993"/>
                    </a:cubicBezTo>
                    <a:lnTo>
                      <a:pt x="354543" y="49161"/>
                    </a:lnTo>
                    <a:lnTo>
                      <a:pt x="325046" y="39329"/>
                    </a:lnTo>
                    <a:cubicBezTo>
                      <a:pt x="296207" y="20103"/>
                      <a:pt x="298619" y="17974"/>
                      <a:pt x="266052" y="9832"/>
                    </a:cubicBezTo>
                    <a:cubicBezTo>
                      <a:pt x="262873" y="9037"/>
                      <a:pt x="272607" y="0"/>
                      <a:pt x="246388" y="0"/>
                    </a:cubicBezTo>
                    <a:close/>
                  </a:path>
                </a:pathLst>
              </a:custGeom>
              <a:noFill/>
              <a:ln w="19050"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2" name="ZoneTexte 21">
                <a:extLst>
                  <a:ext uri="{FF2B5EF4-FFF2-40B4-BE49-F238E27FC236}">
                    <a16:creationId xmlns:a16="http://schemas.microsoft.com/office/drawing/2014/main" id="{195A058B-336F-BE4E-A7BD-8A072B169A80}"/>
                  </a:ext>
                </a:extLst>
              </p:cNvPr>
              <p:cNvSpPr txBox="1"/>
              <p:nvPr/>
            </p:nvSpPr>
            <p:spPr>
              <a:xfrm>
                <a:off x="10849588" y="4474380"/>
                <a:ext cx="54854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dirty="0"/>
                  <a:t>CC4</a:t>
                </a:r>
              </a:p>
            </p:txBody>
          </p:sp>
          <p:sp>
            <p:nvSpPr>
              <p:cNvPr id="23" name="ZoneTexte 22">
                <a:extLst>
                  <a:ext uri="{FF2B5EF4-FFF2-40B4-BE49-F238E27FC236}">
                    <a16:creationId xmlns:a16="http://schemas.microsoft.com/office/drawing/2014/main" id="{98A609E5-E555-8247-9FBB-CEEF856556EC}"/>
                  </a:ext>
                </a:extLst>
              </p:cNvPr>
              <p:cNvSpPr txBox="1"/>
              <p:nvPr/>
            </p:nvSpPr>
            <p:spPr>
              <a:xfrm>
                <a:off x="8877705" y="3488339"/>
                <a:ext cx="54854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dirty="0"/>
                  <a:t>CC5</a:t>
                </a:r>
              </a:p>
            </p:txBody>
          </p:sp>
          <p:sp>
            <p:nvSpPr>
              <p:cNvPr id="24" name="ZoneTexte 23">
                <a:extLst>
                  <a:ext uri="{FF2B5EF4-FFF2-40B4-BE49-F238E27FC236}">
                    <a16:creationId xmlns:a16="http://schemas.microsoft.com/office/drawing/2014/main" id="{80BA87E1-A0D8-2840-9FC3-8F673F84D09F}"/>
                  </a:ext>
                </a:extLst>
              </p:cNvPr>
              <p:cNvSpPr txBox="1"/>
              <p:nvPr/>
            </p:nvSpPr>
            <p:spPr>
              <a:xfrm>
                <a:off x="8050870" y="4973849"/>
                <a:ext cx="54854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dirty="0"/>
                  <a:t>CC1</a:t>
                </a:r>
              </a:p>
            </p:txBody>
          </p:sp>
          <p:sp>
            <p:nvSpPr>
              <p:cNvPr id="25" name="ZoneTexte 24">
                <a:extLst>
                  <a:ext uri="{FF2B5EF4-FFF2-40B4-BE49-F238E27FC236}">
                    <a16:creationId xmlns:a16="http://schemas.microsoft.com/office/drawing/2014/main" id="{B137D149-6904-4244-A2CC-BC876A515075}"/>
                  </a:ext>
                </a:extLst>
              </p:cNvPr>
              <p:cNvSpPr txBox="1"/>
              <p:nvPr/>
            </p:nvSpPr>
            <p:spPr>
              <a:xfrm>
                <a:off x="9868606" y="1706650"/>
                <a:ext cx="54854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dirty="0"/>
                  <a:t>CC2</a:t>
                </a:r>
              </a:p>
            </p:txBody>
          </p:sp>
          <p:sp>
            <p:nvSpPr>
              <p:cNvPr id="26" name="ZoneTexte 25">
                <a:extLst>
                  <a:ext uri="{FF2B5EF4-FFF2-40B4-BE49-F238E27FC236}">
                    <a16:creationId xmlns:a16="http://schemas.microsoft.com/office/drawing/2014/main" id="{7EC7278F-D337-C145-91F8-DCDFFB7BF346}"/>
                  </a:ext>
                </a:extLst>
              </p:cNvPr>
              <p:cNvSpPr txBox="1"/>
              <p:nvPr/>
            </p:nvSpPr>
            <p:spPr>
              <a:xfrm>
                <a:off x="7890908" y="1560113"/>
                <a:ext cx="699230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2400" b="1" dirty="0">
                    <a:solidFill>
                      <a:srgbClr val="4132FF"/>
                    </a:solidFill>
                  </a:rPr>
                  <a:t>GC1</a:t>
                </a:r>
              </a:p>
            </p:txBody>
          </p:sp>
        </p:grpSp>
        <p:sp>
          <p:nvSpPr>
            <p:cNvPr id="6" name="Forme libre 5">
              <a:extLst>
                <a:ext uri="{FF2B5EF4-FFF2-40B4-BE49-F238E27FC236}">
                  <a16:creationId xmlns:a16="http://schemas.microsoft.com/office/drawing/2014/main" id="{D6343719-A5F2-3240-8DD7-D2E3874D3871}"/>
                </a:ext>
              </a:extLst>
            </p:cNvPr>
            <p:cNvSpPr/>
            <p:nvPr/>
          </p:nvSpPr>
          <p:spPr>
            <a:xfrm>
              <a:off x="5402829" y="1381999"/>
              <a:ext cx="6755676" cy="5388697"/>
            </a:xfrm>
            <a:custGeom>
              <a:avLst/>
              <a:gdLst>
                <a:gd name="connsiteX0" fmla="*/ 3248802 w 6755676"/>
                <a:gd name="connsiteY0" fmla="*/ 622647 h 5388697"/>
                <a:gd name="connsiteX1" fmla="*/ 4268709 w 6755676"/>
                <a:gd name="connsiteY1" fmla="*/ 681263 h 5388697"/>
                <a:gd name="connsiteX2" fmla="*/ 4948648 w 6755676"/>
                <a:gd name="connsiteY2" fmla="*/ 646093 h 5388697"/>
                <a:gd name="connsiteX3" fmla="*/ 5722371 w 6755676"/>
                <a:gd name="connsiteY3" fmla="*/ 599201 h 5388697"/>
                <a:gd name="connsiteX4" fmla="*/ 6343694 w 6755676"/>
                <a:gd name="connsiteY4" fmla="*/ 669539 h 5388697"/>
                <a:gd name="connsiteX5" fmla="*/ 6648494 w 6755676"/>
                <a:gd name="connsiteY5" fmla="*/ 810216 h 5388697"/>
                <a:gd name="connsiteX6" fmla="*/ 6754002 w 6755676"/>
                <a:gd name="connsiteY6" fmla="*/ 1103293 h 5388697"/>
                <a:gd name="connsiteX7" fmla="*/ 6695386 w 6755676"/>
                <a:gd name="connsiteY7" fmla="*/ 1537047 h 5388697"/>
                <a:gd name="connsiteX8" fmla="*/ 6472648 w 6755676"/>
                <a:gd name="connsiteY8" fmla="*/ 1947355 h 5388697"/>
                <a:gd name="connsiteX9" fmla="*/ 6367140 w 6755676"/>
                <a:gd name="connsiteY9" fmla="*/ 2216986 h 5388697"/>
                <a:gd name="connsiteX10" fmla="*/ 6331971 w 6755676"/>
                <a:gd name="connsiteY10" fmla="*/ 2662463 h 5388697"/>
                <a:gd name="connsiteX11" fmla="*/ 6437479 w 6755676"/>
                <a:gd name="connsiteY11" fmla="*/ 3072770 h 5388697"/>
                <a:gd name="connsiteX12" fmla="*/ 6484371 w 6755676"/>
                <a:gd name="connsiteY12" fmla="*/ 3529970 h 5388697"/>
                <a:gd name="connsiteX13" fmla="*/ 6144402 w 6755676"/>
                <a:gd name="connsiteY13" fmla="*/ 4116124 h 5388697"/>
                <a:gd name="connsiteX14" fmla="*/ 5511356 w 6755676"/>
                <a:gd name="connsiteY14" fmla="*/ 4538155 h 5388697"/>
                <a:gd name="connsiteX15" fmla="*/ 5124494 w 6755676"/>
                <a:gd name="connsiteY15" fmla="*/ 4772616 h 5388697"/>
                <a:gd name="connsiteX16" fmla="*/ 4632125 w 6755676"/>
                <a:gd name="connsiteY16" fmla="*/ 5159478 h 5388697"/>
                <a:gd name="connsiteX17" fmla="*/ 4198371 w 6755676"/>
                <a:gd name="connsiteY17" fmla="*/ 5323601 h 5388697"/>
                <a:gd name="connsiteX18" fmla="*/ 3635663 w 6755676"/>
                <a:gd name="connsiteY18" fmla="*/ 5382216 h 5388697"/>
                <a:gd name="connsiteX19" fmla="*/ 2920556 w 6755676"/>
                <a:gd name="connsiteY19" fmla="*/ 5182924 h 5388697"/>
                <a:gd name="connsiteX20" fmla="*/ 2510248 w 6755676"/>
                <a:gd name="connsiteY20" fmla="*/ 4526432 h 5388697"/>
                <a:gd name="connsiteX21" fmla="*/ 2217171 w 6755676"/>
                <a:gd name="connsiteY21" fmla="*/ 3858216 h 5388697"/>
                <a:gd name="connsiteX22" fmla="*/ 1806863 w 6755676"/>
                <a:gd name="connsiteY22" fmla="*/ 3389293 h 5388697"/>
                <a:gd name="connsiteX23" fmla="*/ 1197263 w 6755676"/>
                <a:gd name="connsiteY23" fmla="*/ 2803139 h 5388697"/>
                <a:gd name="connsiteX24" fmla="*/ 564217 w 6755676"/>
                <a:gd name="connsiteY24" fmla="*/ 2216986 h 5388697"/>
                <a:gd name="connsiteX25" fmla="*/ 329756 w 6755676"/>
                <a:gd name="connsiteY25" fmla="*/ 1654278 h 5388697"/>
                <a:gd name="connsiteX26" fmla="*/ 165633 w 6755676"/>
                <a:gd name="connsiteY26" fmla="*/ 974339 h 5388697"/>
                <a:gd name="connsiteX27" fmla="*/ 13233 w 6755676"/>
                <a:gd name="connsiteY27" fmla="*/ 540586 h 5388697"/>
                <a:gd name="connsiteX28" fmla="*/ 13233 w 6755676"/>
                <a:gd name="connsiteY28" fmla="*/ 235786 h 5388697"/>
                <a:gd name="connsiteX29" fmla="*/ 60125 w 6755676"/>
                <a:gd name="connsiteY29" fmla="*/ 118555 h 5388697"/>
                <a:gd name="connsiteX30" fmla="*/ 177356 w 6755676"/>
                <a:gd name="connsiteY30" fmla="*/ 36493 h 5388697"/>
                <a:gd name="connsiteX31" fmla="*/ 353202 w 6755676"/>
                <a:gd name="connsiteY31" fmla="*/ 1324 h 5388697"/>
                <a:gd name="connsiteX32" fmla="*/ 599386 w 6755676"/>
                <a:gd name="connsiteY32" fmla="*/ 48216 h 5388697"/>
                <a:gd name="connsiteX33" fmla="*/ 1244156 w 6755676"/>
                <a:gd name="connsiteY33" fmla="*/ 388186 h 5388697"/>
                <a:gd name="connsiteX34" fmla="*/ 1642740 w 6755676"/>
                <a:gd name="connsiteY34" fmla="*/ 540586 h 5388697"/>
                <a:gd name="connsiteX35" fmla="*/ 2346125 w 6755676"/>
                <a:gd name="connsiteY35" fmla="*/ 634370 h 5388697"/>
                <a:gd name="connsiteX36" fmla="*/ 2873663 w 6755676"/>
                <a:gd name="connsiteY36" fmla="*/ 622647 h 5388697"/>
                <a:gd name="connsiteX37" fmla="*/ 3049509 w 6755676"/>
                <a:gd name="connsiteY37" fmla="*/ 622647 h 5388697"/>
                <a:gd name="connsiteX38" fmla="*/ 3248802 w 6755676"/>
                <a:gd name="connsiteY38" fmla="*/ 622647 h 538869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</a:cxnLst>
              <a:rect l="l" t="t" r="r" b="b"/>
              <a:pathLst>
                <a:path w="6755676" h="5388697">
                  <a:moveTo>
                    <a:pt x="3248802" y="622647"/>
                  </a:moveTo>
                  <a:cubicBezTo>
                    <a:pt x="3452002" y="632416"/>
                    <a:pt x="3985401" y="677355"/>
                    <a:pt x="4268709" y="681263"/>
                  </a:cubicBezTo>
                  <a:cubicBezTo>
                    <a:pt x="4552017" y="685171"/>
                    <a:pt x="4948648" y="646093"/>
                    <a:pt x="4948648" y="646093"/>
                  </a:cubicBezTo>
                  <a:cubicBezTo>
                    <a:pt x="5190925" y="632416"/>
                    <a:pt x="5489863" y="595293"/>
                    <a:pt x="5722371" y="599201"/>
                  </a:cubicBezTo>
                  <a:cubicBezTo>
                    <a:pt x="5954879" y="603109"/>
                    <a:pt x="6189340" y="634370"/>
                    <a:pt x="6343694" y="669539"/>
                  </a:cubicBezTo>
                  <a:cubicBezTo>
                    <a:pt x="6498048" y="704708"/>
                    <a:pt x="6580109" y="737924"/>
                    <a:pt x="6648494" y="810216"/>
                  </a:cubicBezTo>
                  <a:cubicBezTo>
                    <a:pt x="6716879" y="882508"/>
                    <a:pt x="6746187" y="982155"/>
                    <a:pt x="6754002" y="1103293"/>
                  </a:cubicBezTo>
                  <a:cubicBezTo>
                    <a:pt x="6761817" y="1224431"/>
                    <a:pt x="6742278" y="1396370"/>
                    <a:pt x="6695386" y="1537047"/>
                  </a:cubicBezTo>
                  <a:cubicBezTo>
                    <a:pt x="6648494" y="1677724"/>
                    <a:pt x="6527356" y="1834032"/>
                    <a:pt x="6472648" y="1947355"/>
                  </a:cubicBezTo>
                  <a:cubicBezTo>
                    <a:pt x="6417940" y="2060678"/>
                    <a:pt x="6390586" y="2097801"/>
                    <a:pt x="6367140" y="2216986"/>
                  </a:cubicBezTo>
                  <a:cubicBezTo>
                    <a:pt x="6343694" y="2336171"/>
                    <a:pt x="6320248" y="2519832"/>
                    <a:pt x="6331971" y="2662463"/>
                  </a:cubicBezTo>
                  <a:cubicBezTo>
                    <a:pt x="6343694" y="2805094"/>
                    <a:pt x="6412079" y="2928186"/>
                    <a:pt x="6437479" y="3072770"/>
                  </a:cubicBezTo>
                  <a:cubicBezTo>
                    <a:pt x="6462879" y="3217354"/>
                    <a:pt x="6533217" y="3356078"/>
                    <a:pt x="6484371" y="3529970"/>
                  </a:cubicBezTo>
                  <a:cubicBezTo>
                    <a:pt x="6435525" y="3703862"/>
                    <a:pt x="6306571" y="3948093"/>
                    <a:pt x="6144402" y="4116124"/>
                  </a:cubicBezTo>
                  <a:cubicBezTo>
                    <a:pt x="5982233" y="4284155"/>
                    <a:pt x="5681341" y="4428740"/>
                    <a:pt x="5511356" y="4538155"/>
                  </a:cubicBezTo>
                  <a:cubicBezTo>
                    <a:pt x="5341371" y="4647570"/>
                    <a:pt x="5271032" y="4669062"/>
                    <a:pt x="5124494" y="4772616"/>
                  </a:cubicBezTo>
                  <a:cubicBezTo>
                    <a:pt x="4977956" y="4876170"/>
                    <a:pt x="4786479" y="5067647"/>
                    <a:pt x="4632125" y="5159478"/>
                  </a:cubicBezTo>
                  <a:cubicBezTo>
                    <a:pt x="4477771" y="5251309"/>
                    <a:pt x="4364448" y="5286478"/>
                    <a:pt x="4198371" y="5323601"/>
                  </a:cubicBezTo>
                  <a:cubicBezTo>
                    <a:pt x="4032294" y="5360724"/>
                    <a:pt x="3848632" y="5405662"/>
                    <a:pt x="3635663" y="5382216"/>
                  </a:cubicBezTo>
                  <a:cubicBezTo>
                    <a:pt x="3422694" y="5358770"/>
                    <a:pt x="3108125" y="5325555"/>
                    <a:pt x="2920556" y="5182924"/>
                  </a:cubicBezTo>
                  <a:cubicBezTo>
                    <a:pt x="2732987" y="5040293"/>
                    <a:pt x="2627479" y="4747217"/>
                    <a:pt x="2510248" y="4526432"/>
                  </a:cubicBezTo>
                  <a:cubicBezTo>
                    <a:pt x="2393017" y="4305647"/>
                    <a:pt x="2334402" y="4047739"/>
                    <a:pt x="2217171" y="3858216"/>
                  </a:cubicBezTo>
                  <a:cubicBezTo>
                    <a:pt x="2099940" y="3668693"/>
                    <a:pt x="1976848" y="3565139"/>
                    <a:pt x="1806863" y="3389293"/>
                  </a:cubicBezTo>
                  <a:cubicBezTo>
                    <a:pt x="1636878" y="3213447"/>
                    <a:pt x="1404371" y="2998524"/>
                    <a:pt x="1197263" y="2803139"/>
                  </a:cubicBezTo>
                  <a:cubicBezTo>
                    <a:pt x="990155" y="2607755"/>
                    <a:pt x="708801" y="2408463"/>
                    <a:pt x="564217" y="2216986"/>
                  </a:cubicBezTo>
                  <a:cubicBezTo>
                    <a:pt x="419632" y="2025509"/>
                    <a:pt x="396187" y="1861386"/>
                    <a:pt x="329756" y="1654278"/>
                  </a:cubicBezTo>
                  <a:cubicBezTo>
                    <a:pt x="263325" y="1447170"/>
                    <a:pt x="218387" y="1159954"/>
                    <a:pt x="165633" y="974339"/>
                  </a:cubicBezTo>
                  <a:cubicBezTo>
                    <a:pt x="112879" y="788724"/>
                    <a:pt x="38633" y="663678"/>
                    <a:pt x="13233" y="540586"/>
                  </a:cubicBezTo>
                  <a:cubicBezTo>
                    <a:pt x="-12167" y="417494"/>
                    <a:pt x="5418" y="306124"/>
                    <a:pt x="13233" y="235786"/>
                  </a:cubicBezTo>
                  <a:cubicBezTo>
                    <a:pt x="21048" y="165448"/>
                    <a:pt x="32771" y="151771"/>
                    <a:pt x="60125" y="118555"/>
                  </a:cubicBezTo>
                  <a:cubicBezTo>
                    <a:pt x="87479" y="85339"/>
                    <a:pt x="128510" y="56031"/>
                    <a:pt x="177356" y="36493"/>
                  </a:cubicBezTo>
                  <a:cubicBezTo>
                    <a:pt x="226202" y="16955"/>
                    <a:pt x="282864" y="-630"/>
                    <a:pt x="353202" y="1324"/>
                  </a:cubicBezTo>
                  <a:cubicBezTo>
                    <a:pt x="423540" y="3278"/>
                    <a:pt x="450894" y="-16261"/>
                    <a:pt x="599386" y="48216"/>
                  </a:cubicBezTo>
                  <a:cubicBezTo>
                    <a:pt x="747878" y="112693"/>
                    <a:pt x="1070264" y="306124"/>
                    <a:pt x="1244156" y="388186"/>
                  </a:cubicBezTo>
                  <a:cubicBezTo>
                    <a:pt x="1418048" y="470248"/>
                    <a:pt x="1459079" y="499555"/>
                    <a:pt x="1642740" y="540586"/>
                  </a:cubicBezTo>
                  <a:cubicBezTo>
                    <a:pt x="1826401" y="581617"/>
                    <a:pt x="2140971" y="620693"/>
                    <a:pt x="2346125" y="634370"/>
                  </a:cubicBezTo>
                  <a:cubicBezTo>
                    <a:pt x="2551279" y="648047"/>
                    <a:pt x="2756432" y="624601"/>
                    <a:pt x="2873663" y="622647"/>
                  </a:cubicBezTo>
                  <a:cubicBezTo>
                    <a:pt x="2990894" y="620693"/>
                    <a:pt x="2986986" y="618739"/>
                    <a:pt x="3049509" y="622647"/>
                  </a:cubicBezTo>
                  <a:cubicBezTo>
                    <a:pt x="3112032" y="626555"/>
                    <a:pt x="3045602" y="612878"/>
                    <a:pt x="3248802" y="622647"/>
                  </a:cubicBezTo>
                  <a:close/>
                </a:path>
              </a:pathLst>
            </a:custGeom>
            <a:noFill/>
            <a:ln w="28575">
              <a:solidFill>
                <a:srgbClr val="3533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grpSp>
        <p:nvGrpSpPr>
          <p:cNvPr id="40" name="Group 39">
            <a:extLst>
              <a:ext uri="{FF2B5EF4-FFF2-40B4-BE49-F238E27FC236}">
                <a16:creationId xmlns:a16="http://schemas.microsoft.com/office/drawing/2014/main" id="{7E4EF898-A9EF-BA49-8926-19BD3513CB5B}"/>
              </a:ext>
            </a:extLst>
          </p:cNvPr>
          <p:cNvGrpSpPr/>
          <p:nvPr/>
        </p:nvGrpSpPr>
        <p:grpSpPr>
          <a:xfrm>
            <a:off x="187494" y="5696912"/>
            <a:ext cx="5143739" cy="307777"/>
            <a:chOff x="158052" y="5533174"/>
            <a:chExt cx="5143739" cy="307777"/>
          </a:xfrm>
        </p:grpSpPr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D9DC03EB-AE64-CC48-B713-4FBA4FD0F066}"/>
                </a:ext>
              </a:extLst>
            </p:cNvPr>
            <p:cNvSpPr/>
            <p:nvPr/>
          </p:nvSpPr>
          <p:spPr>
            <a:xfrm>
              <a:off x="158052" y="5603470"/>
              <a:ext cx="188536" cy="197963"/>
            </a:xfrm>
            <a:prstGeom prst="rect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400"/>
            </a:p>
          </p:txBody>
        </p:sp>
        <p:sp>
          <p:nvSpPr>
            <p:cNvPr id="32" name="ZoneTexte 31">
              <a:extLst>
                <a:ext uri="{FF2B5EF4-FFF2-40B4-BE49-F238E27FC236}">
                  <a16:creationId xmlns:a16="http://schemas.microsoft.com/office/drawing/2014/main" id="{4E673EC4-9282-5449-BDE9-C353EAAAB3FA}"/>
                </a:ext>
              </a:extLst>
            </p:cNvPr>
            <p:cNvSpPr txBox="1"/>
            <p:nvPr/>
          </p:nvSpPr>
          <p:spPr>
            <a:xfrm>
              <a:off x="346588" y="5533174"/>
              <a:ext cx="49552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err="1"/>
                <a:t>gST_C</a:t>
              </a:r>
              <a:r>
                <a:rPr lang="fr-FR" sz="1400" dirty="0"/>
                <a:t> (Xe_09-ST1; Xe_14-ST1; Xe_34-STx; Xe_11-STx; Xe_15-ST1)</a:t>
              </a:r>
            </a:p>
          </p:txBody>
        </p:sp>
      </p:grpSp>
      <p:grpSp>
        <p:nvGrpSpPr>
          <p:cNvPr id="39" name="Group 38">
            <a:extLst>
              <a:ext uri="{FF2B5EF4-FFF2-40B4-BE49-F238E27FC236}">
                <a16:creationId xmlns:a16="http://schemas.microsoft.com/office/drawing/2014/main" id="{2ED50C4F-BC25-4447-9916-43B8D9CA81C8}"/>
              </a:ext>
            </a:extLst>
          </p:cNvPr>
          <p:cNvGrpSpPr/>
          <p:nvPr/>
        </p:nvGrpSpPr>
        <p:grpSpPr>
          <a:xfrm>
            <a:off x="187494" y="5977827"/>
            <a:ext cx="5140404" cy="307777"/>
            <a:chOff x="158052" y="5806512"/>
            <a:chExt cx="5140404" cy="307777"/>
          </a:xfrm>
        </p:grpSpPr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A2940B9A-EF49-6542-8183-4D115195BCC2}"/>
                </a:ext>
              </a:extLst>
            </p:cNvPr>
            <p:cNvSpPr/>
            <p:nvPr/>
          </p:nvSpPr>
          <p:spPr>
            <a:xfrm>
              <a:off x="158052" y="5876808"/>
              <a:ext cx="188536" cy="197963"/>
            </a:xfrm>
            <a:prstGeom prst="rect">
              <a:avLst/>
            </a:prstGeom>
            <a:solidFill>
              <a:srgbClr val="758000"/>
            </a:solidFill>
            <a:ln>
              <a:solidFill>
                <a:srgbClr val="758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400"/>
            </a:p>
          </p:txBody>
        </p:sp>
        <p:sp>
          <p:nvSpPr>
            <p:cNvPr id="33" name="ZoneTexte 32">
              <a:extLst>
                <a:ext uri="{FF2B5EF4-FFF2-40B4-BE49-F238E27FC236}">
                  <a16:creationId xmlns:a16="http://schemas.microsoft.com/office/drawing/2014/main" id="{C0E353B4-28FF-7B4F-A40B-BBE64B74F78D}"/>
                </a:ext>
              </a:extLst>
            </p:cNvPr>
            <p:cNvSpPr txBox="1"/>
            <p:nvPr/>
          </p:nvSpPr>
          <p:spPr>
            <a:xfrm>
              <a:off x="346588" y="5806512"/>
              <a:ext cx="49518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err="1"/>
                <a:t>gST_D</a:t>
              </a:r>
              <a:r>
                <a:rPr lang="fr-FR" sz="1400" dirty="0"/>
                <a:t> (Xe_09-ST1; Xe_14-ST1; Xe_34-STx; Xe_11-ST2; Xe_15-ST1)</a:t>
              </a:r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C0F06108-8E7B-A34C-BA28-F47B3B7A1BF8}"/>
              </a:ext>
            </a:extLst>
          </p:cNvPr>
          <p:cNvGrpSpPr/>
          <p:nvPr/>
        </p:nvGrpSpPr>
        <p:grpSpPr>
          <a:xfrm>
            <a:off x="187494" y="5135082"/>
            <a:ext cx="5194778" cy="307777"/>
            <a:chOff x="158052" y="6050980"/>
            <a:chExt cx="5194778" cy="307777"/>
          </a:xfrm>
        </p:grpSpPr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5AD25D85-86F5-0843-B4AA-3DC33D9F1DAB}"/>
                </a:ext>
              </a:extLst>
            </p:cNvPr>
            <p:cNvSpPr/>
            <p:nvPr/>
          </p:nvSpPr>
          <p:spPr>
            <a:xfrm>
              <a:off x="158052" y="6121276"/>
              <a:ext cx="188536" cy="197963"/>
            </a:xfrm>
            <a:prstGeom prst="rect">
              <a:avLst/>
            </a:prstGeom>
            <a:solidFill>
              <a:srgbClr val="3533FF"/>
            </a:solidFill>
            <a:ln>
              <a:solidFill>
                <a:srgbClr val="3533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400"/>
            </a:p>
          </p:txBody>
        </p:sp>
        <p:sp>
          <p:nvSpPr>
            <p:cNvPr id="34" name="ZoneTexte 33">
              <a:extLst>
                <a:ext uri="{FF2B5EF4-FFF2-40B4-BE49-F238E27FC236}">
                  <a16:creationId xmlns:a16="http://schemas.microsoft.com/office/drawing/2014/main" id="{C67A4CEA-A87E-FA47-85FB-1D1103005A7B}"/>
                </a:ext>
              </a:extLst>
            </p:cNvPr>
            <p:cNvSpPr txBox="1"/>
            <p:nvPr/>
          </p:nvSpPr>
          <p:spPr>
            <a:xfrm>
              <a:off x="346588" y="6050980"/>
              <a:ext cx="500624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err="1"/>
                <a:t>gST_A</a:t>
              </a:r>
              <a:r>
                <a:rPr lang="fr-FR" sz="1400" dirty="0"/>
                <a:t> (Xe_09-ST2; Xe_14-ST2; Xe_34-ST2; Xe_11-ST1; Xe_15-ST2) </a:t>
              </a:r>
            </a:p>
          </p:txBody>
        </p: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3DD5D95A-C93D-F341-822C-257630320CCC}"/>
              </a:ext>
            </a:extLst>
          </p:cNvPr>
          <p:cNvGrpSpPr/>
          <p:nvPr/>
        </p:nvGrpSpPr>
        <p:grpSpPr>
          <a:xfrm>
            <a:off x="187494" y="5415997"/>
            <a:ext cx="5127580" cy="307777"/>
            <a:chOff x="158052" y="6334382"/>
            <a:chExt cx="5127580" cy="307777"/>
          </a:xfrm>
        </p:grpSpPr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36F1674C-ABE9-414A-96E6-7337E4453C12}"/>
                </a:ext>
              </a:extLst>
            </p:cNvPr>
            <p:cNvSpPr/>
            <p:nvPr/>
          </p:nvSpPr>
          <p:spPr>
            <a:xfrm>
              <a:off x="158052" y="6404678"/>
              <a:ext cx="188536" cy="197963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400"/>
            </a:p>
          </p:txBody>
        </p:sp>
        <p:sp>
          <p:nvSpPr>
            <p:cNvPr id="35" name="ZoneTexte 34">
              <a:extLst>
                <a:ext uri="{FF2B5EF4-FFF2-40B4-BE49-F238E27FC236}">
                  <a16:creationId xmlns:a16="http://schemas.microsoft.com/office/drawing/2014/main" id="{986DF9B2-174E-714E-8FBD-58C4B4A1420D}"/>
                </a:ext>
              </a:extLst>
            </p:cNvPr>
            <p:cNvSpPr txBox="1"/>
            <p:nvPr/>
          </p:nvSpPr>
          <p:spPr>
            <a:xfrm>
              <a:off x="346588" y="6334382"/>
              <a:ext cx="493904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err="1"/>
                <a:t>gST_B</a:t>
              </a:r>
              <a:r>
                <a:rPr lang="fr-FR" sz="1400" dirty="0"/>
                <a:t> (Xe_09-ST2; Xe_14-ST2; Xe_34-ST1; Xe_11-ST1; Xe_15-STx)</a:t>
              </a:r>
            </a:p>
          </p:txBody>
        </p:sp>
      </p:grpSp>
      <p:grpSp>
        <p:nvGrpSpPr>
          <p:cNvPr id="41" name="Group 40">
            <a:extLst>
              <a:ext uri="{FF2B5EF4-FFF2-40B4-BE49-F238E27FC236}">
                <a16:creationId xmlns:a16="http://schemas.microsoft.com/office/drawing/2014/main" id="{4127611D-B811-A140-AE44-3DD6D0A7050A}"/>
              </a:ext>
            </a:extLst>
          </p:cNvPr>
          <p:cNvGrpSpPr/>
          <p:nvPr/>
        </p:nvGrpSpPr>
        <p:grpSpPr>
          <a:xfrm>
            <a:off x="187494" y="6258743"/>
            <a:ext cx="5097252" cy="307777"/>
            <a:chOff x="158052" y="5268634"/>
            <a:chExt cx="5097252" cy="307777"/>
          </a:xfrm>
        </p:grpSpPr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FAA0E4C8-A882-124A-A111-8DB9EECAC5A0}"/>
                </a:ext>
              </a:extLst>
            </p:cNvPr>
            <p:cNvSpPr/>
            <p:nvPr/>
          </p:nvSpPr>
          <p:spPr>
            <a:xfrm>
              <a:off x="158052" y="5338930"/>
              <a:ext cx="188536" cy="197963"/>
            </a:xfrm>
            <a:prstGeom prst="rect">
              <a:avLst/>
            </a:prstGeom>
            <a:solidFill>
              <a:srgbClr val="7F007D"/>
            </a:solidFill>
            <a:ln>
              <a:solidFill>
                <a:srgbClr val="7F007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400"/>
            </a:p>
          </p:txBody>
        </p:sp>
        <p:sp>
          <p:nvSpPr>
            <p:cNvPr id="37" name="ZoneTexte 36">
              <a:extLst>
                <a:ext uri="{FF2B5EF4-FFF2-40B4-BE49-F238E27FC236}">
                  <a16:creationId xmlns:a16="http://schemas.microsoft.com/office/drawing/2014/main" id="{52E7E2C1-6D41-9D4D-8464-016555D94400}"/>
                </a:ext>
              </a:extLst>
            </p:cNvPr>
            <p:cNvSpPr txBox="1"/>
            <p:nvPr/>
          </p:nvSpPr>
          <p:spPr>
            <a:xfrm>
              <a:off x="346588" y="5268634"/>
              <a:ext cx="490871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err="1"/>
                <a:t>gST_E</a:t>
              </a:r>
              <a:r>
                <a:rPr lang="fr-FR" sz="1400" dirty="0"/>
                <a:t> (Xe_09-ST1; Xe_14-ST1; Xe_34-STx; Xe_11-STx; Xe_15-ST2)</a:t>
              </a:r>
            </a:p>
          </p:txBody>
        </p:sp>
      </p:grpSp>
      <p:sp>
        <p:nvSpPr>
          <p:cNvPr id="38" name="ZoneTexte 37">
            <a:extLst>
              <a:ext uri="{FF2B5EF4-FFF2-40B4-BE49-F238E27FC236}">
                <a16:creationId xmlns:a16="http://schemas.microsoft.com/office/drawing/2014/main" id="{7F9F2538-8354-8741-BEC2-A786B4910321}"/>
              </a:ext>
            </a:extLst>
          </p:cNvPr>
          <p:cNvSpPr txBox="1"/>
          <p:nvPr/>
        </p:nvSpPr>
        <p:spPr>
          <a:xfrm>
            <a:off x="212568" y="70410"/>
            <a:ext cx="11768418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2000" b="1" dirty="0"/>
              <a:t>Figure S1. </a:t>
            </a:r>
            <a:r>
              <a:rPr lang="fr-FR" sz="2000" dirty="0" err="1"/>
              <a:t>Categorical</a:t>
            </a:r>
            <a:r>
              <a:rPr lang="fr-FR" sz="2000" dirty="0"/>
              <a:t> minimum </a:t>
            </a:r>
            <a:r>
              <a:rPr lang="fr-FR" sz="2000" dirty="0" err="1"/>
              <a:t>spanning</a:t>
            </a:r>
            <a:r>
              <a:rPr lang="fr-FR" sz="2000" dirty="0"/>
              <a:t> </a:t>
            </a:r>
            <a:r>
              <a:rPr lang="fr-FR" sz="2000" dirty="0" err="1"/>
              <a:t>tree</a:t>
            </a:r>
            <a:r>
              <a:rPr lang="fr-FR" sz="2000" dirty="0"/>
              <a:t> </a:t>
            </a:r>
            <a:r>
              <a:rPr lang="fr-FR" sz="2000" dirty="0" err="1"/>
              <a:t>from</a:t>
            </a:r>
            <a:r>
              <a:rPr lang="fr-FR" sz="2000" dirty="0"/>
              <a:t> the VNTR-</a:t>
            </a:r>
            <a:r>
              <a:rPr lang="fr-FR" sz="2000" dirty="0" err="1"/>
              <a:t>rep</a:t>
            </a:r>
            <a:r>
              <a:rPr lang="fr-FR" sz="2000" dirty="0"/>
              <a:t> </a:t>
            </a:r>
            <a:r>
              <a:rPr lang="fr-FR" sz="2000" dirty="0" err="1"/>
              <a:t>dataset</a:t>
            </a:r>
            <a:r>
              <a:rPr lang="fr-FR" sz="2000" dirty="0"/>
              <a:t> </a:t>
            </a:r>
            <a:r>
              <a:rPr lang="fr-FR" sz="2000" dirty="0" err="1"/>
              <a:t>using</a:t>
            </a:r>
            <a:r>
              <a:rPr lang="fr-FR" sz="2000" dirty="0"/>
              <a:t> the </a:t>
            </a:r>
            <a:r>
              <a:rPr lang="fr-FR" sz="2000" dirty="0" err="1"/>
              <a:t>goeBURST</a:t>
            </a:r>
            <a:r>
              <a:rPr lang="fr-FR" sz="2000"/>
              <a:t> and </a:t>
            </a:r>
            <a:r>
              <a:rPr lang="fr-FR" sz="2000" dirty="0" err="1"/>
              <a:t>Euclidian</a:t>
            </a:r>
            <a:r>
              <a:rPr lang="fr-FR" sz="2000" dirty="0"/>
              <a:t> </a:t>
            </a:r>
            <a:r>
              <a:rPr lang="fr-FR" sz="2000" dirty="0" err="1"/>
              <a:t>algorithms</a:t>
            </a:r>
            <a:r>
              <a:rPr lang="fr-FR" sz="2000" dirty="0"/>
              <a:t>. </a:t>
            </a:r>
            <a:r>
              <a:rPr lang="fr-FR" sz="2000" dirty="0" err="1"/>
              <a:t>Colors</a:t>
            </a:r>
            <a:r>
              <a:rPr lang="fr-FR" sz="2000" dirty="0"/>
              <a:t> </a:t>
            </a:r>
            <a:r>
              <a:rPr lang="fr-FR" sz="2000" dirty="0" err="1"/>
              <a:t>indicate</a:t>
            </a:r>
            <a:r>
              <a:rPr lang="fr-FR" sz="2000" dirty="0"/>
              <a:t> the global </a:t>
            </a:r>
            <a:r>
              <a:rPr lang="fr-FR" sz="2000" dirty="0" err="1"/>
              <a:t>sequence</a:t>
            </a:r>
            <a:r>
              <a:rPr lang="fr-FR" sz="2000" dirty="0"/>
              <a:t> type (Table S1) </a:t>
            </a:r>
            <a:r>
              <a:rPr lang="fr-FR" sz="2000" dirty="0" err="1"/>
              <a:t>based</a:t>
            </a:r>
            <a:r>
              <a:rPr lang="fr-FR" sz="2000" dirty="0"/>
              <a:t> on SNP data for the 36 MLVA haplotypes. </a:t>
            </a:r>
            <a:r>
              <a:rPr lang="fr-FR" sz="2000" dirty="0" err="1"/>
              <a:t>Sequence</a:t>
            </a:r>
            <a:r>
              <a:rPr lang="fr-FR" sz="2000" dirty="0"/>
              <a:t> types (</a:t>
            </a:r>
            <a:r>
              <a:rPr lang="fr-FR" sz="2000" dirty="0" err="1"/>
              <a:t>STs</a:t>
            </a:r>
            <a:r>
              <a:rPr lang="fr-FR" sz="2000" dirty="0"/>
              <a:t>) are </a:t>
            </a:r>
            <a:r>
              <a:rPr lang="fr-FR" sz="2000" dirty="0" err="1"/>
              <a:t>given</a:t>
            </a:r>
            <a:r>
              <a:rPr lang="fr-FR" sz="2000" dirty="0"/>
              <a:t> </a:t>
            </a:r>
            <a:r>
              <a:rPr lang="fr-FR" sz="2000" dirty="0" err="1"/>
              <a:t>when</a:t>
            </a:r>
            <a:r>
              <a:rPr lang="fr-FR" sz="2000" dirty="0"/>
              <a:t> </a:t>
            </a:r>
            <a:r>
              <a:rPr lang="fr-FR" sz="2000" dirty="0" err="1"/>
              <a:t>clearly</a:t>
            </a:r>
            <a:r>
              <a:rPr lang="fr-FR" sz="2000" dirty="0"/>
              <a:t> </a:t>
            </a:r>
            <a:r>
              <a:rPr lang="fr-FR" sz="2000" dirty="0" err="1"/>
              <a:t>identified</a:t>
            </a:r>
            <a:r>
              <a:rPr lang="fr-FR" sz="2000" dirty="0"/>
              <a:t> (Table 2). </a:t>
            </a:r>
            <a:r>
              <a:rPr lang="fr-FR" sz="2000" dirty="0" err="1"/>
              <a:t>STx</a:t>
            </a:r>
            <a:r>
              <a:rPr lang="fr-FR" sz="2000" dirty="0"/>
              <a:t> </a:t>
            </a:r>
            <a:r>
              <a:rPr lang="fr-FR" sz="2000" dirty="0" err="1"/>
              <a:t>indicates</a:t>
            </a:r>
            <a:r>
              <a:rPr lang="fr-FR" sz="2000" dirty="0"/>
              <a:t> </a:t>
            </a:r>
            <a:r>
              <a:rPr lang="fr-FR" sz="2000" dirty="0" err="1"/>
              <a:t>that</a:t>
            </a:r>
            <a:r>
              <a:rPr lang="fr-FR" sz="2000" dirty="0"/>
              <a:t> the </a:t>
            </a:r>
            <a:r>
              <a:rPr lang="fr-FR" sz="2000" dirty="0" err="1"/>
              <a:t>allele</a:t>
            </a:r>
            <a:r>
              <a:rPr lang="fr-FR" sz="2000" dirty="0"/>
              <a:t> of the locus </a:t>
            </a:r>
            <a:r>
              <a:rPr lang="fr-FR" sz="2000" dirty="0" err="1"/>
              <a:t>could</a:t>
            </a:r>
            <a:r>
              <a:rPr lang="fr-FR" sz="2000" dirty="0"/>
              <a:t> </a:t>
            </a:r>
            <a:r>
              <a:rPr lang="fr-FR" sz="2000" dirty="0" err="1"/>
              <a:t>originate</a:t>
            </a:r>
            <a:r>
              <a:rPr lang="fr-FR" sz="2000" dirty="0"/>
              <a:t> </a:t>
            </a:r>
            <a:r>
              <a:rPr lang="fr-FR" sz="2000" dirty="0" err="1"/>
              <a:t>from</a:t>
            </a:r>
            <a:r>
              <a:rPr lang="fr-FR" sz="2000" dirty="0"/>
              <a:t> or </a:t>
            </a:r>
            <a:r>
              <a:rPr lang="fr-FR" sz="2000" dirty="0" err="1"/>
              <a:t>be</a:t>
            </a:r>
            <a:r>
              <a:rPr lang="fr-FR" sz="2000" dirty="0"/>
              <a:t> the </a:t>
            </a:r>
            <a:r>
              <a:rPr lang="fr-FR" sz="2000" dirty="0" err="1"/>
              <a:t>ancestor</a:t>
            </a:r>
            <a:r>
              <a:rPr lang="fr-FR" sz="2000" dirty="0"/>
              <a:t> of </a:t>
            </a:r>
            <a:r>
              <a:rPr lang="fr-FR" sz="2000" dirty="0" err="1"/>
              <a:t>any</a:t>
            </a:r>
            <a:r>
              <a:rPr lang="fr-FR" sz="2000" dirty="0"/>
              <a:t> </a:t>
            </a:r>
            <a:r>
              <a:rPr lang="fr-FR" sz="2000" dirty="0" err="1"/>
              <a:t>combination</a:t>
            </a:r>
            <a:r>
              <a:rPr lang="fr-FR" sz="2000" dirty="0"/>
              <a:t> of </a:t>
            </a:r>
            <a:r>
              <a:rPr lang="fr-FR" sz="2000" dirty="0" err="1"/>
              <a:t>repeats</a:t>
            </a:r>
            <a:r>
              <a:rPr lang="fr-FR" sz="2000" dirty="0"/>
              <a:t> </a:t>
            </a:r>
            <a:r>
              <a:rPr lang="fr-FR" sz="2000" dirty="0" err="1"/>
              <a:t>defined</a:t>
            </a:r>
            <a:r>
              <a:rPr lang="fr-FR" sz="2000" dirty="0"/>
              <a:t> by the </a:t>
            </a:r>
            <a:r>
              <a:rPr lang="fr-FR" sz="2000" dirty="0" err="1"/>
              <a:t>different</a:t>
            </a:r>
            <a:r>
              <a:rPr lang="fr-FR" sz="2000" dirty="0"/>
              <a:t> </a:t>
            </a:r>
            <a:r>
              <a:rPr lang="fr-FR" sz="2000" dirty="0" err="1"/>
              <a:t>STs</a:t>
            </a:r>
            <a:r>
              <a:rPr lang="fr-FR" sz="20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77938072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7</TotalTime>
  <Words>208</Words>
  <Application>Microsoft Macintosh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Microsoft Office</dc:creator>
  <cp:lastModifiedBy>Microsoft Office User</cp:lastModifiedBy>
  <cp:revision>11</cp:revision>
  <dcterms:created xsi:type="dcterms:W3CDTF">2021-02-22T09:36:38Z</dcterms:created>
  <dcterms:modified xsi:type="dcterms:W3CDTF">2021-02-24T11:32:48Z</dcterms:modified>
</cp:coreProperties>
</file>